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EE192-262F-4FB4-9367-B9B12C5F31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A21CFA-67AF-4426-9567-D180639A70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A235B2-8A08-49EC-8805-5BD02074D92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243360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5464440"/>
            <a:ext cx="19044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670C96-94F1-4D76-9DC9-BF463185DF0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751"/>
              </a:spcBef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7D2DD4-1A6C-4CDC-8CAA-1EC931D74C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F618A9-4659-499D-BC3B-AD08B2F98B1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27CCDE-344B-460B-A241-5CCFF2FFCD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63BF1A-7FC5-4E53-850A-CBD01E1E44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487440"/>
            <a:ext cx="5914800" cy="8191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751"/>
              </a:spcBef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E5CBE1-0E1F-42AF-BDD4-2BFC0562BA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5408BB-2A57-48A1-BA14-F67D0FABCB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546444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CF81C-8D8F-4F08-9ACE-6C1F167ECC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2433600"/>
            <a:ext cx="288612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5464440"/>
            <a:ext cx="5914800" cy="2767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7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B0A863-83C1-4546-B072-B7B54E9D0A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487440"/>
            <a:ext cx="5914800" cy="1766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2433600"/>
            <a:ext cx="5914800" cy="5802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713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1" marL="5144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2" marL="8571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3" marL="120024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4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5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  <a:p>
            <a:pPr lvl="6" marL="1542960" indent="-171360">
              <a:lnSpc>
                <a:spcPct val="90000"/>
              </a:lnSpc>
              <a:spcBef>
                <a:spcPts val="7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1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8475480"/>
            <a:ext cx="23148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8475480"/>
            <a:ext cx="154296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9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EA335B9-1CAE-4E70-A1B7-1622142E17F8}" type="slidenum">
              <a:rPr b="0" lang="zh-CN" sz="9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文本框 7"/>
          <p:cNvSpPr/>
          <p:nvPr/>
        </p:nvSpPr>
        <p:spPr>
          <a:xfrm>
            <a:off x="928800" y="615960"/>
            <a:ext cx="9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 Box 11"/>
          <p:cNvSpPr/>
          <p:nvPr/>
        </p:nvSpPr>
        <p:spPr>
          <a:xfrm>
            <a:off x="1219680" y="919080"/>
            <a:ext cx="1155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XM_015764399.1/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LOC_Os12g42550.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Line 3"/>
          <p:cNvSpPr/>
          <p:nvPr/>
        </p:nvSpPr>
        <p:spPr>
          <a:xfrm>
            <a:off x="2401920" y="1090440"/>
            <a:ext cx="3635280" cy="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tangle 4"/>
          <p:cNvSpPr/>
          <p:nvPr/>
        </p:nvSpPr>
        <p:spPr>
          <a:xfrm>
            <a:off x="2403360" y="1017720"/>
            <a:ext cx="114480" cy="1429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tangle 5"/>
          <p:cNvSpPr/>
          <p:nvPr/>
        </p:nvSpPr>
        <p:spPr>
          <a:xfrm>
            <a:off x="5224320" y="1015920"/>
            <a:ext cx="128880" cy="14472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Line 13"/>
          <p:cNvSpPr/>
          <p:nvPr/>
        </p:nvSpPr>
        <p:spPr>
          <a:xfrm>
            <a:off x="2403360" y="982800"/>
            <a:ext cx="0" cy="5396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Line 14"/>
          <p:cNvSpPr/>
          <p:nvPr/>
        </p:nvSpPr>
        <p:spPr>
          <a:xfrm>
            <a:off x="6048360" y="984240"/>
            <a:ext cx="0" cy="5396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 Box 16"/>
          <p:cNvSpPr/>
          <p:nvPr/>
        </p:nvSpPr>
        <p:spPr>
          <a:xfrm>
            <a:off x="2284200" y="804960"/>
            <a:ext cx="241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Text Box 17"/>
          <p:cNvSpPr/>
          <p:nvPr/>
        </p:nvSpPr>
        <p:spPr>
          <a:xfrm>
            <a:off x="5841000" y="80316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402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直接连接符 37"/>
          <p:cNvSpPr/>
          <p:nvPr/>
        </p:nvSpPr>
        <p:spPr>
          <a:xfrm>
            <a:off x="5778360" y="1779480"/>
            <a:ext cx="27000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34"/>
          <p:cNvSpPr/>
          <p:nvPr/>
        </p:nvSpPr>
        <p:spPr>
          <a:xfrm>
            <a:off x="5675760" y="1758960"/>
            <a:ext cx="5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300 b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Rectangle 5"/>
          <p:cNvSpPr/>
          <p:nvPr/>
        </p:nvSpPr>
        <p:spPr>
          <a:xfrm>
            <a:off x="5468760" y="1017720"/>
            <a:ext cx="579600" cy="144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 Box 16"/>
          <p:cNvSpPr/>
          <p:nvPr/>
        </p:nvSpPr>
        <p:spPr>
          <a:xfrm>
            <a:off x="2377080" y="80316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12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Line 13"/>
          <p:cNvSpPr/>
          <p:nvPr/>
        </p:nvSpPr>
        <p:spPr>
          <a:xfrm>
            <a:off x="2517840" y="984240"/>
            <a:ext cx="0" cy="5396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Line 13"/>
          <p:cNvSpPr/>
          <p:nvPr/>
        </p:nvSpPr>
        <p:spPr>
          <a:xfrm>
            <a:off x="5224320" y="984240"/>
            <a:ext cx="0" cy="179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 Box 16"/>
          <p:cNvSpPr/>
          <p:nvPr/>
        </p:nvSpPr>
        <p:spPr>
          <a:xfrm>
            <a:off x="4983480" y="80316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3121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 Box 16"/>
          <p:cNvSpPr/>
          <p:nvPr/>
        </p:nvSpPr>
        <p:spPr>
          <a:xfrm>
            <a:off x="5142240" y="64296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3226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Line 13"/>
          <p:cNvSpPr/>
          <p:nvPr/>
        </p:nvSpPr>
        <p:spPr>
          <a:xfrm>
            <a:off x="5353200" y="822240"/>
            <a:ext cx="0" cy="71928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ine 13"/>
          <p:cNvSpPr/>
          <p:nvPr/>
        </p:nvSpPr>
        <p:spPr>
          <a:xfrm>
            <a:off x="5468760" y="984240"/>
            <a:ext cx="0" cy="539640"/>
          </a:xfrm>
          <a:prstGeom prst="line">
            <a:avLst/>
          </a:prstGeom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 Box 16"/>
          <p:cNvSpPr/>
          <p:nvPr/>
        </p:nvSpPr>
        <p:spPr>
          <a:xfrm>
            <a:off x="5285160" y="80316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3379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 Box 11"/>
          <p:cNvSpPr/>
          <p:nvPr/>
        </p:nvSpPr>
        <p:spPr>
          <a:xfrm>
            <a:off x="1212840" y="1327320"/>
            <a:ext cx="1155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XM_015764400.2/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LOC_Os12g42550.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3"/>
          <p:cNvSpPr/>
          <p:nvPr/>
        </p:nvSpPr>
        <p:spPr>
          <a:xfrm>
            <a:off x="2401920" y="1496880"/>
            <a:ext cx="3635280" cy="0"/>
          </a:xfrm>
          <a:prstGeom prst="line">
            <a:avLst/>
          </a:prstGeom>
          <a:ln w="31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Rectangle 4"/>
          <p:cNvSpPr/>
          <p:nvPr/>
        </p:nvSpPr>
        <p:spPr>
          <a:xfrm>
            <a:off x="2403360" y="1424160"/>
            <a:ext cx="114480" cy="1425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Rectangle 5"/>
          <p:cNvSpPr/>
          <p:nvPr/>
        </p:nvSpPr>
        <p:spPr>
          <a:xfrm>
            <a:off x="5232240" y="1422360"/>
            <a:ext cx="122400" cy="144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Rectangle 5"/>
          <p:cNvSpPr/>
          <p:nvPr/>
        </p:nvSpPr>
        <p:spPr>
          <a:xfrm>
            <a:off x="5468760" y="1424160"/>
            <a:ext cx="579600" cy="14436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 Box 16"/>
          <p:cNvSpPr/>
          <p:nvPr/>
        </p:nvSpPr>
        <p:spPr>
          <a:xfrm>
            <a:off x="2223000" y="15336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ATG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Line 13"/>
          <p:cNvSpPr/>
          <p:nvPr/>
        </p:nvSpPr>
        <p:spPr>
          <a:xfrm>
            <a:off x="5232240" y="1390680"/>
            <a:ext cx="0" cy="179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 Box 16"/>
          <p:cNvSpPr/>
          <p:nvPr/>
        </p:nvSpPr>
        <p:spPr>
          <a:xfrm>
            <a:off x="4983480" y="120960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3133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 Box 16"/>
          <p:cNvSpPr/>
          <p:nvPr/>
        </p:nvSpPr>
        <p:spPr>
          <a:xfrm>
            <a:off x="5873760" y="1533600"/>
            <a:ext cx="363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TGA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矩形 12"/>
          <p:cNvSpPr/>
          <p:nvPr/>
        </p:nvSpPr>
        <p:spPr>
          <a:xfrm>
            <a:off x="833400" y="2193840"/>
            <a:ext cx="5450040" cy="6089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ATGGCCACGGCCGGCGACGAGCAGCAGCAGCAGGCGGCGGCGGCGCAGACGGCGGAGGTG   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ATGGCCACGGCCGGCGACGAGCAGCAGCAGCAGGCGGCGGCGGCGCAGACGGCGGAGGTG   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2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ACGGAGGCGGCGGC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GAAGGAGGTGGTGTCCGTG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GAGATGCCGGCGCCGGAGGGGTGGACG   1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ACGGAGGCGGCGGC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GAAGGAGGTGGTGTCCGTG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GAGATGCCGGCGCCGGAGGGGTGGACG   1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AAGAAGTTTACTCCCCAGAGAGGGGGGAGATTTGAGATTGTTTTTGTTTCACCAACTGGA   18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AAGA------------AGAGAGGGGGGAGATTTGAGAT</a:t>
            </a:r>
            <a:r>
              <a:rPr b="0" lang="en-US" sz="800" spc="-1" strike="noStrike">
                <a:solidFill>
                  <a:srgbClr val="000000"/>
                </a:solidFill>
                <a:latin typeface="Courier New"/>
                <a:ea typeface="Courier New"/>
              </a:rPr>
              <a:t>TGTTTTTGTTTCACCAACTGGA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16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12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AAGAGATTAAGAACAAGAGACAGCTGAGCCAGTATCTGAAGGCACACCCTGGAGGCCCT   2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 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GAAGAGATTAAGAACAAGAGACAGCTGAGCCAGTATCTGAAGGCACACCCTGGAGGCCCT   22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CATCCTCAGAGTTTGATTGGGGAACTGGTGATACTCCAAGGCGCTCTGCTCGCATTAGC   3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CATCCTCAGAGTTTGATTGGGGAACTGGTGATACTCCAAGGCGCTCTGCTCGCATTAGC   28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AGAAAGTTAAGGCTTTCGATAGCCCAGAAGGGGAGAAGATCCCGAAACGTTCTAGGAAC   3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AGAAAGTTAAGGCTTTCGATAGCCCAGAAGGGGAGAAGATCCCGAAACGTTCTAGGAAC   34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TCATCTGGCAGAAAGGGCAAGCAGGAGAAAAAGGAGGCCACCGAAAATGAAGAAGCGAAA   4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TCATCTGGCAGAAAGGGCAAGCAGGAGAAAAAGGAGGCCACCGAAAATGAAGAAGCGAAA   40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ACGCTGAAGCTGACAAGGAGGCCCCTAGCGAAGATGCTCCAAAGGAGACTGATGTAGAG   48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ACGCTGAAGCTGACAAGGAGGCCCCTAGCGAAGATGCTCCAAAGGAGACTGATGTAGAG   46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ACAAAGCCTGCTGAAGAGGCGAAGGAGGCCCCTAGCGAAGATGCTCCAAAAGACACCGAT   5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 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ACAAAGCCTGCTGAAGAGGCGAAGGAGGCCCCTAGCGAAGATGCTCCAAAAGACACCGAT   52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 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GTGGAGATGAAAACTGCTGAAGATGCCAGCAAGACCGCAGACGCCGACACTCCTGCTCCA   6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 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GTGGAGATGAAAACTGCTGAAGATGCCAGCAAGACCGCAGACGCCGACACTCCTGCTCCA   58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CACCAGCCGGAACCGAGAAGGAAGATGCAAAACCGGCTGAATCTGAGGCTGCTCCTCCA   66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CACCAGCCGGAACCGAGAAGGAAGATGCAAAACCGGCTGAATCTGAGGCTGCTCCTCCA   64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CACCATCGGAAGGAGGAGAGAAGAAAGAGGATGCAAAGCCAGCTGAACCTGAAGCAGCA   72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CACCATCGGAAGGAGGAGAGAAGAAAGAGGATGCAAAGCCAGCTGAACCTGAAGCAGCA   70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CTGCTCCACCAAGCAACCCAACTGAGCCTTCCGCACCCAAAGCTGCTGCTGCTGCTCCA   78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CTGCTCCACCAAGCAACCCAACTGAGCCTTCCGCACCCAAAGCTGCTGCTGCTGCTCCA   76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TAGAGAACTCCGCGGACAAAGGCCCTCACCAGGACAGCCAGCCGCCTTCCGCCGCCGCC   84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GTAGAGAACTCCGCGGACAAAGGCCCTCACCAGGACAGCCAGCCGCCTTCCGCCGCCGCC   82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CCCGCCAAGGAGTCATCCCCTGTCAACAACGGGCAGCTGCCGGCTGGTGCCTCTGCCGTG   9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CCCGCCAAGGAGTCATCCCCTGTCAACAACGGGCAGCTGCCGGCTGGTGCCTCTGCCGTG   888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899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AAGTGCACCTGA   912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AAGTGCACCTGA   900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 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1" name="直接箭头连接符 14"/>
          <p:cNvCxnSpPr/>
          <p:nvPr/>
        </p:nvCxnSpPr>
        <p:spPr>
          <a:xfrm>
            <a:off x="2921040" y="2617560"/>
            <a:ext cx="11390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72" name="直接箭头连接符 84"/>
          <p:cNvCxnSpPr/>
          <p:nvPr/>
        </p:nvCxnSpPr>
        <p:spPr>
          <a:xfrm flipH="1" flipV="1">
            <a:off x="4370040" y="3326760"/>
            <a:ext cx="132120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73" name="文本框 7"/>
          <p:cNvSpPr/>
          <p:nvPr/>
        </p:nvSpPr>
        <p:spPr>
          <a:xfrm>
            <a:off x="928800" y="1949400"/>
            <a:ext cx="9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文本框 35"/>
          <p:cNvSpPr/>
          <p:nvPr/>
        </p:nvSpPr>
        <p:spPr>
          <a:xfrm>
            <a:off x="836640" y="8429760"/>
            <a:ext cx="5391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3: Figure S1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Detection of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transcript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图片 3" descr=""/>
          <p:cNvPicPr/>
          <p:nvPr/>
        </p:nvPicPr>
        <p:blipFill>
          <a:blip r:embed="rId1"/>
          <a:stretch/>
        </p:blipFill>
        <p:spPr>
          <a:xfrm>
            <a:off x="1397160" y="668160"/>
            <a:ext cx="4816440" cy="3598920"/>
          </a:xfrm>
          <a:prstGeom prst="rect">
            <a:avLst/>
          </a:prstGeom>
          <a:ln w="0">
            <a:noFill/>
          </a:ln>
        </p:spPr>
      </p:pic>
      <p:sp>
        <p:nvSpPr>
          <p:cNvPr id="76" name="文本框 7"/>
          <p:cNvSpPr/>
          <p:nvPr/>
        </p:nvSpPr>
        <p:spPr>
          <a:xfrm>
            <a:off x="981000" y="407880"/>
            <a:ext cx="9072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矩形 5"/>
          <p:cNvSpPr/>
          <p:nvPr/>
        </p:nvSpPr>
        <p:spPr>
          <a:xfrm>
            <a:off x="638280" y="6559560"/>
            <a:ext cx="5848200" cy="1944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(Continued)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5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Additional File 3: Figure S1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. Detection of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transcript. (A) Schematic diagrams of predicted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splicing variants. (B) Sequence alignment of predicted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splicing variants. Sequences for primers designed to distinguish the two predicted alternative transcripts (predicted amplification sizes of 106 bp and 94 bp for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XM_015764399.1/LOC_Os12g42550.1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and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XM_015764400.2/LOC_Os12g42550.2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, respectively.) are indicated by arrow. (C) RT-PCR analysis for detecting predicted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OsMBD707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splicing variants. Only an amplification size of 106 bp for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XM_015764399.1/LOC_Os12g42550.1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was detected in the roots, stems, leaves, spikelets, seeds, and panicle axes. The rice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Actin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gene was used as an internal control. (D) Sequencing confirmation of the 106 bp-amplified product of </a:t>
            </a:r>
            <a:r>
              <a:rPr b="0" i="1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XM_015764399.1/LOC_Os12g42550.1</a:t>
            </a: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.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文本框 7"/>
          <p:cNvSpPr/>
          <p:nvPr/>
        </p:nvSpPr>
        <p:spPr>
          <a:xfrm>
            <a:off x="982800" y="4665600"/>
            <a:ext cx="9036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等线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矩形 2"/>
          <p:cNvSpPr/>
          <p:nvPr/>
        </p:nvSpPr>
        <p:spPr>
          <a:xfrm>
            <a:off x="739800" y="4862520"/>
            <a:ext cx="5668920" cy="47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ts val="998"/>
              </a:lnSpc>
              <a:tabLst>
                <a:tab algn="l" pos="0"/>
                <a:tab algn="l" pos="581040"/>
                <a:tab algn="l" pos="1162080"/>
                <a:tab algn="l" pos="1744560"/>
                <a:tab algn="l" pos="2325600"/>
                <a:tab algn="l" pos="2908440"/>
                <a:tab algn="l" pos="3489480"/>
                <a:tab algn="l" pos="4070520"/>
                <a:tab algn="l" pos="4653000"/>
                <a:tab algn="l" pos="5234040"/>
                <a:tab algn="l" pos="5816520"/>
                <a:tab algn="l" pos="6397560"/>
                <a:tab algn="l" pos="6978600"/>
                <a:tab algn="l" pos="7561440"/>
                <a:tab algn="l" pos="8142120"/>
                <a:tab algn="l" pos="8724960"/>
                <a:tab algn="l" pos="9306000"/>
                <a:tab algn="l" pos="9601200"/>
                <a:tab algn="l" pos="10058400"/>
                <a:tab algn="l" pos="105156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XM_015764399.1/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581040"/>
                <a:tab algn="l" pos="1162080"/>
                <a:tab algn="l" pos="1744560"/>
                <a:tab algn="l" pos="2325600"/>
                <a:tab algn="l" pos="2908440"/>
                <a:tab algn="l" pos="3489480"/>
                <a:tab algn="l" pos="4070520"/>
                <a:tab algn="l" pos="4653000"/>
                <a:tab algn="l" pos="5234040"/>
                <a:tab algn="l" pos="5816520"/>
                <a:tab algn="l" pos="6397560"/>
                <a:tab algn="l" pos="6978600"/>
                <a:tab algn="l" pos="7561440"/>
                <a:tab algn="l" pos="8142120"/>
                <a:tab algn="l" pos="8724960"/>
                <a:tab algn="l" pos="9306000"/>
                <a:tab algn="l" pos="9601200"/>
                <a:tab algn="l" pos="10058400"/>
                <a:tab algn="l" pos="105156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1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CGCCGGAGGGGTGGACGAAGAAGTTTACTCCCCAGAGAGGGGGGAGATTTGAGATTGTTTTTGTTTCAC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ts val="998"/>
              </a:lnSpc>
              <a:tabLst>
                <a:tab algn="l" pos="0"/>
                <a:tab algn="l" pos="581040"/>
                <a:tab algn="l" pos="1162080"/>
                <a:tab algn="l" pos="1744560"/>
                <a:tab algn="l" pos="2325600"/>
                <a:tab algn="l" pos="2908440"/>
                <a:tab algn="l" pos="3489480"/>
                <a:tab algn="l" pos="4070520"/>
                <a:tab algn="l" pos="4653000"/>
                <a:tab algn="l" pos="5234040"/>
                <a:tab algn="l" pos="5816520"/>
                <a:tab algn="l" pos="6397560"/>
                <a:tab algn="l" pos="6978600"/>
                <a:tab algn="l" pos="7561440"/>
                <a:tab algn="l" pos="8142120"/>
                <a:tab algn="l" pos="8724960"/>
                <a:tab algn="l" pos="9306000"/>
                <a:tab algn="l" pos="9601200"/>
                <a:tab algn="l" pos="10058400"/>
                <a:tab algn="l" pos="10515600"/>
              </a:tabLst>
            </a:pPr>
            <a:r>
              <a:rPr b="0" i="1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LOC_Os12g42550.2</a:t>
            </a:r>
            <a:r>
              <a:rPr b="0" lang="en-US" sz="800" spc="-1" strike="noStrike">
                <a:solidFill>
                  <a:srgbClr val="222222"/>
                </a:solidFill>
                <a:latin typeface="Courier New"/>
                <a:ea typeface="Courier New"/>
              </a:rPr>
              <a:t>   CGCCGGAGGGGTGGACGAAGA------------AGAGAGGGGGGAGATTTGAGATTGTTTTTGTTTCACC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0" name="图片 5" descr=""/>
          <p:cNvPicPr/>
          <p:nvPr/>
        </p:nvPicPr>
        <p:blipFill>
          <a:blip r:embed="rId2"/>
          <a:stretch/>
        </p:blipFill>
        <p:spPr>
          <a:xfrm>
            <a:off x="1395360" y="5538960"/>
            <a:ext cx="4822920" cy="779400"/>
          </a:xfrm>
          <a:prstGeom prst="rect">
            <a:avLst/>
          </a:prstGeom>
          <a:ln w="0">
            <a:noFill/>
          </a:ln>
        </p:spPr>
      </p:pic>
      <p:sp>
        <p:nvSpPr>
          <p:cNvPr id="81" name="直接连接符 22"/>
          <p:cNvSpPr/>
          <p:nvPr/>
        </p:nvSpPr>
        <p:spPr>
          <a:xfrm>
            <a:off x="6183360" y="5291280"/>
            <a:ext cx="0" cy="252360"/>
          </a:xfrm>
          <a:prstGeom prst="line">
            <a:avLst/>
          </a:prstGeom>
          <a:ln w="1260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直接连接符 23"/>
          <p:cNvSpPr/>
          <p:nvPr/>
        </p:nvSpPr>
        <p:spPr>
          <a:xfrm flipH="1">
            <a:off x="1432080" y="5288040"/>
            <a:ext cx="574560" cy="252360"/>
          </a:xfrm>
          <a:prstGeom prst="line">
            <a:avLst/>
          </a:prstGeom>
          <a:ln w="1260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直接连接符 7"/>
          <p:cNvSpPr/>
          <p:nvPr/>
        </p:nvSpPr>
        <p:spPr>
          <a:xfrm>
            <a:off x="2870280" y="5648400"/>
            <a:ext cx="792000" cy="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直接连接符 4"/>
          <p:cNvSpPr/>
          <p:nvPr/>
        </p:nvSpPr>
        <p:spPr>
          <a:xfrm>
            <a:off x="1612800" y="1503360"/>
            <a:ext cx="181080" cy="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文本框 13"/>
          <p:cNvSpPr/>
          <p:nvPr/>
        </p:nvSpPr>
        <p:spPr>
          <a:xfrm>
            <a:off x="1062360" y="139536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2000 b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直接连接符 28"/>
          <p:cNvSpPr/>
          <p:nvPr/>
        </p:nvSpPr>
        <p:spPr>
          <a:xfrm>
            <a:off x="1612800" y="1703520"/>
            <a:ext cx="181080" cy="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7" name="文本框 13"/>
          <p:cNvSpPr/>
          <p:nvPr/>
        </p:nvSpPr>
        <p:spPr>
          <a:xfrm>
            <a:off x="1062360" y="1595520"/>
            <a:ext cx="607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1000 b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直接连接符 32"/>
          <p:cNvSpPr/>
          <p:nvPr/>
        </p:nvSpPr>
        <p:spPr>
          <a:xfrm>
            <a:off x="1612800" y="1828800"/>
            <a:ext cx="181080" cy="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文本框 13"/>
          <p:cNvSpPr/>
          <p:nvPr/>
        </p:nvSpPr>
        <p:spPr>
          <a:xfrm>
            <a:off x="1122120" y="1722600"/>
            <a:ext cx="5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750 b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直接连接符 35"/>
          <p:cNvSpPr/>
          <p:nvPr/>
        </p:nvSpPr>
        <p:spPr>
          <a:xfrm>
            <a:off x="1614600" y="1943280"/>
            <a:ext cx="179280" cy="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文本框 13"/>
          <p:cNvSpPr/>
          <p:nvPr/>
        </p:nvSpPr>
        <p:spPr>
          <a:xfrm>
            <a:off x="1122120" y="1836720"/>
            <a:ext cx="5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500 b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直接连接符 37"/>
          <p:cNvSpPr/>
          <p:nvPr/>
        </p:nvSpPr>
        <p:spPr>
          <a:xfrm>
            <a:off x="1614600" y="2209680"/>
            <a:ext cx="179280" cy="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文本框 13"/>
          <p:cNvSpPr/>
          <p:nvPr/>
        </p:nvSpPr>
        <p:spPr>
          <a:xfrm>
            <a:off x="1120680" y="2103480"/>
            <a:ext cx="5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250 b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直接连接符 39"/>
          <p:cNvSpPr/>
          <p:nvPr/>
        </p:nvSpPr>
        <p:spPr>
          <a:xfrm>
            <a:off x="1614600" y="2494080"/>
            <a:ext cx="179280" cy="0"/>
          </a:xfrm>
          <a:prstGeom prst="line">
            <a:avLst/>
          </a:prstGeom>
          <a:ln w="1260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文本框 13"/>
          <p:cNvSpPr/>
          <p:nvPr/>
        </p:nvSpPr>
        <p:spPr>
          <a:xfrm>
            <a:off x="1120680" y="2386080"/>
            <a:ext cx="5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100 bp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文本框 94"/>
          <p:cNvSpPr/>
          <p:nvPr/>
        </p:nvSpPr>
        <p:spPr>
          <a:xfrm rot="3000000">
            <a:off x="2016360" y="87444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Ro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文本框 94"/>
          <p:cNvSpPr/>
          <p:nvPr/>
        </p:nvSpPr>
        <p:spPr>
          <a:xfrm rot="3000000">
            <a:off x="2317680" y="86796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Ste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文本框 94"/>
          <p:cNvSpPr/>
          <p:nvPr/>
        </p:nvSpPr>
        <p:spPr>
          <a:xfrm rot="3000000">
            <a:off x="2619720" y="88236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Lea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文本框 94"/>
          <p:cNvSpPr/>
          <p:nvPr/>
        </p:nvSpPr>
        <p:spPr>
          <a:xfrm rot="3000000">
            <a:off x="2726280" y="78300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Spikele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文本框 94"/>
          <p:cNvSpPr/>
          <p:nvPr/>
        </p:nvSpPr>
        <p:spPr>
          <a:xfrm rot="3000000">
            <a:off x="3209760" y="86868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See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文本框 94"/>
          <p:cNvSpPr/>
          <p:nvPr/>
        </p:nvSpPr>
        <p:spPr>
          <a:xfrm rot="3000000">
            <a:off x="3108960" y="695880"/>
            <a:ext cx="91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Panicle axi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文本框 94"/>
          <p:cNvSpPr/>
          <p:nvPr/>
        </p:nvSpPr>
        <p:spPr>
          <a:xfrm rot="3000000">
            <a:off x="1601640" y="830160"/>
            <a:ext cx="546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Marker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文本框 94"/>
          <p:cNvSpPr/>
          <p:nvPr/>
        </p:nvSpPr>
        <p:spPr>
          <a:xfrm rot="3000000">
            <a:off x="3829320" y="87444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Roo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文本框 94"/>
          <p:cNvSpPr/>
          <p:nvPr/>
        </p:nvSpPr>
        <p:spPr>
          <a:xfrm rot="3000000">
            <a:off x="4130640" y="86796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Stem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文本框 94"/>
          <p:cNvSpPr/>
          <p:nvPr/>
        </p:nvSpPr>
        <p:spPr>
          <a:xfrm rot="3000000">
            <a:off x="4432680" y="88236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Leaf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6" name="文本框 94"/>
          <p:cNvSpPr/>
          <p:nvPr/>
        </p:nvSpPr>
        <p:spPr>
          <a:xfrm rot="3000000">
            <a:off x="4539240" y="783000"/>
            <a:ext cx="668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Spikelet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文本框 94"/>
          <p:cNvSpPr/>
          <p:nvPr/>
        </p:nvSpPr>
        <p:spPr>
          <a:xfrm rot="3000000">
            <a:off x="5022720" y="868680"/>
            <a:ext cx="424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Seed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文本框 94"/>
          <p:cNvSpPr/>
          <p:nvPr/>
        </p:nvSpPr>
        <p:spPr>
          <a:xfrm rot="3000000">
            <a:off x="4941000" y="695880"/>
            <a:ext cx="91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等线"/>
              </a:rPr>
              <a:t>Panicle axis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09" name="直接箭头连接符 51"/>
          <p:cNvCxnSpPr/>
          <p:nvPr/>
        </p:nvCxnSpPr>
        <p:spPr>
          <a:xfrm flipH="1" flipV="1">
            <a:off x="5772960" y="2388600"/>
            <a:ext cx="181800" cy="1080"/>
          </a:xfrm>
          <a:prstGeom prst="straightConnector1">
            <a:avLst/>
          </a:prstGeom>
          <a:ln w="1260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110" name="文本框 13"/>
          <p:cNvSpPr/>
          <p:nvPr/>
        </p:nvSpPr>
        <p:spPr>
          <a:xfrm>
            <a:off x="5894280" y="2281320"/>
            <a:ext cx="48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Actin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111" name="直接箭头连接符 53"/>
          <p:cNvCxnSpPr/>
          <p:nvPr/>
        </p:nvCxnSpPr>
        <p:spPr>
          <a:xfrm flipH="1" flipV="1">
            <a:off x="3948840" y="2459880"/>
            <a:ext cx="181800" cy="1080"/>
          </a:xfrm>
          <a:prstGeom prst="straightConnector1">
            <a:avLst/>
          </a:prstGeom>
          <a:ln w="12600">
            <a:solidFill>
              <a:srgbClr val="ff0000"/>
            </a:solidFill>
            <a:miter/>
            <a:tailEnd len="med" type="triangle" w="med"/>
          </a:ln>
        </p:spPr>
      </p:cxnSp>
      <p:sp>
        <p:nvSpPr>
          <p:cNvPr id="112" name="文本框 68"/>
          <p:cNvSpPr/>
          <p:nvPr/>
        </p:nvSpPr>
        <p:spPr>
          <a:xfrm>
            <a:off x="4068720" y="2368440"/>
            <a:ext cx="1776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XM_015764399.1/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i="1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LOC_Os12g42550.1 </a:t>
            </a:r>
            <a:r>
              <a:rPr b="0" lang="en-US" sz="800" spc="-1" strike="noStrike">
                <a:solidFill>
                  <a:srgbClr val="ff0000"/>
                </a:solidFill>
                <a:latin typeface="Courier New"/>
                <a:ea typeface="Courier New"/>
              </a:rPr>
              <a:t>(106 bp)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6-01T05:41:34Z</dcterms:created>
  <dc:creator>csb</dc:creator>
  <dc:description/>
  <dc:language>en-US</dc:language>
  <cp:lastModifiedBy>csb</cp:lastModifiedBy>
  <cp:lastPrinted>2020-07-06T01:35:58Z</cp:lastPrinted>
  <dcterms:modified xsi:type="dcterms:W3CDTF">2021-02-02T14:41:53Z</dcterms:modified>
  <cp:revision>165</cp:revision>
  <dc:subject/>
  <dc:title>PowerPoint 演示文稿</dc:title>
</cp:coreProperties>
</file>